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BCA45E-C4A8-0CF6-93A4-ADBDE540CD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7CA61B-4605-FF00-ED3A-C62F63BC8E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8A3125-60C6-9BF8-21DD-17D5B0ED3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B5C491-B3EA-3043-2BE5-E5943F70F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3EEE5-305E-792C-2FF5-2ED232FA9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959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85C8B-E3AC-3202-7C3C-FE791668D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3FF06-FA9B-E7C5-AC3D-44751C1861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5ADD92-8BC9-5C38-CEA1-44E2CEC2E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8AAC6-61C1-7A32-9669-C5664551D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BD95FD-907D-C6E5-4517-6E03ABA50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784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057F6D-9C41-0995-7045-A5701340CC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517461-1E1E-1384-CB8C-AAF79EAD1D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C56CCD-A1AD-F6ED-723A-3B88191F4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6B959E-3A61-DD9E-DC6E-CB2D54961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C1715-B889-A772-E23A-2BEC04294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519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7B720F-EA89-D7D4-625C-4377133EC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B21F9C-ED05-FA8B-BD6D-6DCB2DEAE3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0F937-FE04-5D20-C06A-60C75926D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94D67F-7E77-7B4B-0A86-3344D6A70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32313B-4682-91EC-C8D1-7BD837A51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171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9FFA17-5279-483C-AFF1-F5BE09C03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9C18FF-736D-9B75-D114-76B332947F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3B6739-5D16-9370-1CBC-E2F72295F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CF15B6-55CB-CF24-BA36-D1D336F03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0F708-78D3-D20C-33F0-17FF850F7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166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8DC02-F384-0691-20D2-4776D5CC3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41A24F-01CF-1FF9-B72F-BBD047C374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945A9E-6F86-73F4-BC3F-78B8AAE138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060FF2-794F-CE00-7B4A-26FBD0009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A6A9D7-245A-B658-1851-D94A57F21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36C47D-46E8-A574-D5EC-12BE40DCC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881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A3099A-01B8-9A65-868B-977854AE52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C42625-0B31-2964-471D-E71BF7F236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741764-0FCF-F999-1D32-4FF30E364F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57A0F9-0F46-B17B-4AB4-D5D3BA16A7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5E2FB28-9818-3040-0E33-645EC2C902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16869B-21EA-B73C-1421-26847DBE2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3F5CA65-FA9E-501E-32FF-DE3DDF552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9693E8-EDDE-1902-1CAB-8A6C5B5E4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608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2D69A-A432-FDA2-EF9A-DB6684907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14E056-8AAA-2887-893D-7BB9F31BA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690A5A-070A-6B09-5878-D5AFD8E46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0178A0-8CE5-2EB2-46C4-816A671EB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41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866E51-7D76-37BC-52E7-41EA885A1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85878D-AF0B-8FDE-5B54-40C437D0B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63B68C-1E4A-D3FA-A7CE-760BA5D7F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76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AB8C19-C590-56D4-1C32-CB5680E98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BB5238-4922-888A-79BB-24E5097D3E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88B32E-AE16-39B1-16CA-7E211D1D3C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470905-98BF-BD33-6510-E55B8380A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B9FACA-3E5A-99F1-5320-3FA20830F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78642F-CD11-C277-7B41-A8D796256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586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743524-4D2F-BA25-DF2F-21E5BA1BA1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26CE7B-96C0-FA20-4463-1E051A1642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3CC797-FA86-BFFE-D980-5E0BB4A741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C6C5FF-0B07-8C6C-0CA5-DBEC0E23B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900482-0390-54B3-DC10-EDC8CFFFF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793884-0538-0141-9169-6ED19A6F9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13D92B-9DF5-9033-482B-69397D4EE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DEB105-549A-ADB3-74F5-D416BD207E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7D5F0-EBDB-F23E-712E-C63D352DCF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5DDC1D-A359-4C48-A463-0F9D4F2F0561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AE57BF-E4F4-CF5F-0266-B967496CC9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D40908-28F6-EEFD-4522-1BF3E730C1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BD6145-52E9-EA45-8969-38A2AA5F1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08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2C78E1F-E00F-7432-8EF2-A3E7EEED6E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1798955"/>
            <a:ext cx="3962400" cy="326009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A394F98-82A1-F921-06E0-7F0CC4E93F8E}"/>
              </a:ext>
            </a:extLst>
          </p:cNvPr>
          <p:cNvSpPr txBox="1"/>
          <p:nvPr/>
        </p:nvSpPr>
        <p:spPr>
          <a:xfrm>
            <a:off x="2186151" y="5139559"/>
            <a:ext cx="910195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/>
              <a:t>Figure </a:t>
            </a:r>
            <a:r>
              <a:rPr lang="en-US" sz="900" b="1" dirty="0"/>
              <a:t>S6</a:t>
            </a:r>
            <a:r>
              <a:rPr lang="en-US" sz="900" dirty="0"/>
              <a:t>. Morphological phenotype changes of Actinobacteria during co-culturing over time</a:t>
            </a:r>
            <a:r>
              <a:rPr lang="en-US" sz="900" i="1" dirty="0"/>
              <a:t>.</a:t>
            </a:r>
            <a:r>
              <a:rPr lang="en-US" sz="900" dirty="0"/>
              <a:t> Representative images showing the morphological responses of Actinobacteria isolates during co-cultivation monitored at 24-, 48-, 72-, and 144-hour post-inoculation.  </a:t>
            </a:r>
          </a:p>
          <a:p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33562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sea Masaki</dc:creator>
  <cp:lastModifiedBy>MDPI</cp:lastModifiedBy>
  <cp:revision>2</cp:revision>
  <dcterms:created xsi:type="dcterms:W3CDTF">2025-09-25T11:10:40Z</dcterms:created>
  <dcterms:modified xsi:type="dcterms:W3CDTF">2025-10-17T14:34:32Z</dcterms:modified>
</cp:coreProperties>
</file>